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54" d="100"/>
          <a:sy n="54" d="100"/>
        </p:scale>
        <p:origin x="12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68ACB6-6CAB-43F8-BE78-3B5CBC485B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43A8CF9-8F24-4413-B163-C7B64089F1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4F96E6-9B8C-43B3-8BC0-3DDD38F8F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D9ECBE-A487-47E1-A9A0-FE9726697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FBCF54-2180-4D7E-A92F-1D205F2D7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0209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9A332B-D29E-48E4-837B-AE3C5836EF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DA72B7C-2795-434B-ABA3-4F4C0DBC44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6BFF17F-2A94-4489-9BAD-B6B8C27BA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00B877-F418-46B4-AC2E-CD2CB8012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480AAB-AEB1-4FF3-980D-2FEB404F8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1770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ED9CF76-1B9E-47A6-AA7D-CCECF2FC58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5809E4C-80F6-44B4-BDBF-6885598EC7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7B8001-51BD-4128-AD09-7BDB20B6D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6E1805-DEF8-482B-BFD2-E0CDA7EB0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1EDD37-001A-4117-BEE0-C1F1AF6DC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387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C0BC17-BF1B-418E-A6B0-3D80D0268B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FFB20A7-B709-4C32-B73F-D174AE6F0C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0A95FA-C3C2-462D-B832-0F3E99471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8DE55A-8E2C-425A-A54D-9ED293FEE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D2353F-3CC3-48CA-B788-982F1C100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9369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1E64C7-1EEB-463F-8769-8A3244ED43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89D7AAA-F978-4EEB-BA8C-05447C3CE3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598546-180F-4FCD-964C-AD5E8D39F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1A0145-027E-4DD7-8EA5-FFB0B4F59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2602C9-B585-4C41-97F5-3F3CE647F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445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BF8009-EAD2-463E-8528-8373F7683B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13F9AEB-3415-4FB6-BE95-8AD4425392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CCB8764-8F4E-4264-B243-7B4AADD073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4533E36-3A1E-4824-956A-5CF5BE117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FB2D331-25A3-4382-983C-232D122C8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4C5E540-C4C3-4FDD-9CAC-ABD547B35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5533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159DD7-3BB8-43C5-9A4C-8586B3625D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6E212BA-C791-4A9A-8834-EDE112A87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9449607-F7C6-4F55-9F9B-170F662AA3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9283DC5-4534-40F7-B70C-DFA6C141CE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D77F9C-7998-470E-91FB-74D95E5B42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10A9CC1-E7D7-4707-942B-E05CD3415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B18A347-F6A7-4C19-89CA-107E9FDBD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E6018D4-4E10-49D0-9592-9DEFE5287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6673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B79EC1-CD40-4B48-A730-9B0F5B6BBF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3761FBB-DBF9-457D-8242-6E7C421FB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9F1744C-D4F7-42B2-8DFA-EE28D85F8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3D7461E-EDBE-4C6A-BA1E-35276CB08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66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A934904-DB68-407C-ABA9-2A71F764D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BA74EAF-24B7-4BAD-8CAB-B7C823DCE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39199A2-A3A9-467D-BD75-8F00A714E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176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BC749C-E83E-4A10-95BF-25FD8678CD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4954B1E-1F5C-42B7-85DE-47E92F1B8E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D7CE639-EBC6-4CFB-B790-7C0238E356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DB9BCCC-790D-4BC6-AC27-F41840AE1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C11121F-3A49-4CF5-848A-E5B11BACA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3B69B9-A589-4A77-A935-7FC8E714E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045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4B5463-4CD0-4C89-B9B7-D4137FD1AB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C494D3C-D56E-4694-BBAD-7C5352E6D3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09A4501-C9CC-4688-8597-D221754AB5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DFF6425-3DD9-4013-BBF3-BDDF3E8DA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F0259E0-22F6-4828-AAD3-9B6CA1DF7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1221CB2-EF61-47FF-AF31-F187D20E6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3824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4AA6733-621E-49AA-8C2B-905F5F3D12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DADBBB-66E9-4357-BDEA-798FBCA785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0E31E5-339C-4562-B8D0-D85315F3CC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BAEDA-324F-45C2-9463-216F8977E82D}" type="datetimeFigureOut">
              <a:rPr lang="zh-CN" altLang="en-US" smtClean="0"/>
              <a:t>2019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49C582-DE0E-4AA8-8C2B-D1E8EEC123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985C31-851E-4E7D-91E7-A8136C7CED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2C420-605E-4E98-8205-661B63625C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7555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>
            <a:extLst>
              <a:ext uri="{FF2B5EF4-FFF2-40B4-BE49-F238E27FC236}">
                <a16:creationId xmlns:a16="http://schemas.microsoft.com/office/drawing/2014/main" id="{63249960-C6B4-48D7-95C2-9AACA12121A3}"/>
              </a:ext>
            </a:extLst>
          </p:cNvPr>
          <p:cNvSpPr/>
          <p:nvPr/>
        </p:nvSpPr>
        <p:spPr>
          <a:xfrm>
            <a:off x="0" y="3886230"/>
            <a:ext cx="11906250" cy="21200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dditional files 1: Figure. S1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Detection of the different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ry8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-like transgene regions in the eight transgenic lines by PCR. Detection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ry8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-like coding region in T</a:t>
            </a:r>
            <a:r>
              <a:rPr lang="en-US" altLang="zh-CN" kern="1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0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and T</a:t>
            </a:r>
            <a:r>
              <a:rPr lang="en-US" altLang="zh-CN" kern="1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1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D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generation of plants. Detection of the 35S promoter in T</a:t>
            </a:r>
            <a:r>
              <a:rPr lang="en-US" altLang="zh-CN" kern="1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0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and T</a:t>
            </a:r>
            <a:r>
              <a:rPr lang="en-US" altLang="zh-CN" kern="1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1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E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generation of transgenic plants. Detection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Nos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terminator in T</a:t>
            </a:r>
            <a:r>
              <a:rPr lang="en-US" altLang="zh-CN" kern="1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0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and T</a:t>
            </a:r>
            <a:r>
              <a:rPr lang="en-US" altLang="zh-CN" kern="1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1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generation of plants. Lane M: DL2000 DNA molecular weight marker; P: pCAMBIA3300-cry8-like plasmid; C: control 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Jinong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28; W: negative control (water). 1–8: different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ry8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-like transgenic soybean lines.</a:t>
            </a:r>
            <a:endParaRPr lang="zh-CN" altLang="zh-CN" sz="16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31664AF-816A-4EAF-B386-80B835F0EE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9778"/>
            <a:ext cx="12192000" cy="3536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5322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115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i Qin</dc:creator>
  <cp:lastModifiedBy>Di Qin</cp:lastModifiedBy>
  <cp:revision>9</cp:revision>
  <dcterms:created xsi:type="dcterms:W3CDTF">2019-06-17T06:03:30Z</dcterms:created>
  <dcterms:modified xsi:type="dcterms:W3CDTF">2019-09-07T16:00:28Z</dcterms:modified>
</cp:coreProperties>
</file>